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801600" cy="9601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38147-C2B9-4482-9004-A774DC9018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555048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5DCF5-ADE4-4AA1-B060-9058C5F2F8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C981F-FAE3-4C94-AEC5-A4085A978B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80A08-7DD2-483C-B900-90A341B144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25"/>
              </a:spcBef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85435-104D-45FD-B111-5CED6E2A18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B7498-11A9-46A2-9B10-349A2BFF07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FBE69-562D-4F18-9BBF-2FF44EA1F3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B0B82-F180-4922-8255-14D6E2925A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383760"/>
            <a:ext cx="1152216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25"/>
              </a:spcBef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7293D-5688-4756-A3CD-3884DAD805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510E3-0F6C-435D-95EC-3FBD98FAED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EF095-2E9C-4626-A54C-02F57E886C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D1AB5-24DC-4559-BB37-5C8F00D15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marL="479520" indent="-47952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1" marL="1039680" indent="-399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2" marL="1600200" indent="-31896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3" marL="2239920" indent="-318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4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5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6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8899560"/>
            <a:ext cx="298764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ja-JP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13331A12-A085-4BD6-A1CB-F938235D1C88}" type="datetime">
              <a:rPr b="0" lang="ja-JP" sz="17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8899560"/>
            <a:ext cx="405432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8899560"/>
            <a:ext cx="298764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ja-JP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D26CD3F9-8DF4-469E-9146-15308E12C00E}" type="slidenum">
              <a:rPr b="0" lang="ja-JP" sz="1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2133720" y="385920"/>
            <a:ext cx="8848440" cy="3911400"/>
          </a:xfrm>
          <a:prstGeom prst="rect">
            <a:avLst/>
          </a:prstGeom>
          <a:ln w="0">
            <a:noFill/>
          </a:ln>
        </p:spPr>
      </p:pic>
      <p:pic>
        <p:nvPicPr>
          <p:cNvPr id="42" name="グラフ 5" descr=""/>
          <p:cNvPicPr/>
          <p:nvPr/>
        </p:nvPicPr>
        <p:blipFill>
          <a:blip r:embed="rId2"/>
          <a:stretch/>
        </p:blipFill>
        <p:spPr>
          <a:xfrm>
            <a:off x="2133720" y="5218200"/>
            <a:ext cx="8534160" cy="414792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7"/>
          <p:cNvSpPr/>
          <p:nvPr/>
        </p:nvSpPr>
        <p:spPr>
          <a:xfrm>
            <a:off x="4868640" y="4100400"/>
            <a:ext cx="1845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bsolute (</a:t>
            </a:r>
            <a:r>
              <a:rPr b="0" lang="en-US" sz="2000" spc="-1" strike="noStrike">
                <a:solidFill>
                  <a:srgbClr val="000000"/>
                </a:solidFill>
                <a:latin typeface="Symbol"/>
                <a:ea typeface="Symbol"/>
              </a:rPr>
              <a:t>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t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8"/>
          <p:cNvSpPr/>
          <p:nvPr/>
        </p:nvSpPr>
        <p:spPr>
          <a:xfrm rot="16200000">
            <a:off x="1146960" y="6550560"/>
            <a:ext cx="1845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bsolute (</a:t>
            </a:r>
            <a:r>
              <a:rPr b="0" lang="en-US" sz="2000" spc="-1" strike="noStrike">
                <a:solidFill>
                  <a:srgbClr val="000000"/>
                </a:solidFill>
                <a:latin typeface="Symbol"/>
                <a:ea typeface="Symbol"/>
              </a:rPr>
              <a:t>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t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9"/>
          <p:cNvSpPr/>
          <p:nvPr/>
        </p:nvSpPr>
        <p:spPr>
          <a:xfrm rot="16200000">
            <a:off x="1180080" y="1752840"/>
            <a:ext cx="1738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requency</a:t>
            </a: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 (%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811080" y="4358520"/>
            <a:ext cx="1149192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Distribution of perturbation magnitudes between significant and non-significant edge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9"/>
          <p:cNvSpPr/>
          <p:nvPr/>
        </p:nvSpPr>
        <p:spPr>
          <a:xfrm>
            <a:off x="2070000" y="9144720"/>
            <a:ext cx="912204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Magnitude of perturbation for significant and non-significant group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7"/>
          <p:cNvSpPr/>
          <p:nvPr/>
        </p:nvSpPr>
        <p:spPr>
          <a:xfrm>
            <a:off x="900720" y="596880"/>
            <a:ext cx="628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S1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7"/>
          <p:cNvSpPr/>
          <p:nvPr/>
        </p:nvSpPr>
        <p:spPr>
          <a:xfrm>
            <a:off x="903960" y="5218200"/>
            <a:ext cx="628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S2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4"/>
          <p:cNvSpPr/>
          <p:nvPr/>
        </p:nvSpPr>
        <p:spPr>
          <a:xfrm>
            <a:off x="76680" y="12600"/>
            <a:ext cx="2751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ヒラギノ角ゴ ProN"/>
              </a:rPr>
              <a:t>Additional data file 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4T10:55:48Z</dcterms:created>
  <dc:creator>外丸 靖浩</dc:creator>
  <dc:description/>
  <dc:language>en-US</dc:language>
  <cp:lastModifiedBy>外丸 靖浩</cp:lastModifiedBy>
  <dcterms:modified xsi:type="dcterms:W3CDTF">2009-10-23T08:58:10Z</dcterms:modified>
  <cp:revision>9</cp:revision>
  <dc:subject/>
  <dc:title>スライド 1</dc:title>
</cp:coreProperties>
</file>